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2" r:id="rId2"/>
    <p:sldId id="261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078" autoAdjust="0"/>
    <p:restoredTop sz="94660"/>
  </p:normalViewPr>
  <p:slideViewPr>
    <p:cSldViewPr snapToGrid="0">
      <p:cViewPr varScale="1">
        <p:scale>
          <a:sx n="91" d="100"/>
          <a:sy n="91" d="100"/>
        </p:scale>
        <p:origin x="69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FEEA4F0-D6B1-4C17-93E1-1F654FD1EFC1}" type="datetimeFigureOut">
              <a:rPr kumimoji="1" lang="ja-JP" altLang="en-US" smtClean="0"/>
              <a:t>2022/7/2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D5A008B-8BE0-4B65-B78B-F95D261D30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35633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8903ED7-9FF3-4A59-8846-FECAA36B2391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14680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900EAC4-0D51-4E93-8895-18827CDB5A2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DFADBE7B-6A84-471A-8BEE-111918B745D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B7BBDFA-5F89-4313-AEB4-5E038B5278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7295F-7E20-4672-AE34-97ECF590DF7F}" type="datetimeFigureOut">
              <a:rPr kumimoji="1" lang="ja-JP" altLang="en-US" smtClean="0"/>
              <a:t>2022/7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B840A25-51C2-4C60-A337-18A0206BF7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ECB4E70-9FF1-4372-9FCC-0B0486190D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187A9-53BA-4621-AE58-ABD66CC17D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29723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F93D116-D9BE-4878-B65C-8AF39027D9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7194F92-08A8-46CF-94E5-0F0B296CFE5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A5CEC12-A3D1-4654-848F-370234EB35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7295F-7E20-4672-AE34-97ECF590DF7F}" type="datetimeFigureOut">
              <a:rPr kumimoji="1" lang="ja-JP" altLang="en-US" smtClean="0"/>
              <a:t>2022/7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1B95BB2-0BA1-46A4-A2EF-AC73F5D53B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8209CF1-563A-4B9D-9849-0F0237DFAE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187A9-53BA-4621-AE58-ABD66CC17D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54266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70B32384-D188-4005-887A-D39EA08EFFE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39B12F1-3BD4-4CA1-8546-4B6F8184D1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24B2630-78D9-4022-8CC0-2F210884FD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7295F-7E20-4672-AE34-97ECF590DF7F}" type="datetimeFigureOut">
              <a:rPr kumimoji="1" lang="ja-JP" altLang="en-US" smtClean="0"/>
              <a:t>2022/7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AEE3D0D-7382-4CF2-AD22-E4CDFF8B5F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552EDDD-2CE7-4860-B40A-9260818FB3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187A9-53BA-4621-AE58-ABD66CC17D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40117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65EF080-8472-4470-89AD-F771563E83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2F166BB-3194-4BB1-A71F-46648FF6725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AF49193-C802-48D5-A46D-02BE04B29F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7295F-7E20-4672-AE34-97ECF590DF7F}" type="datetimeFigureOut">
              <a:rPr kumimoji="1" lang="ja-JP" altLang="en-US" smtClean="0"/>
              <a:t>2022/7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DE7A0DB-122D-46E8-92EA-9A3EDE93E6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CC797EA-3D89-4032-9C73-094753935E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187A9-53BA-4621-AE58-ABD66CC17D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60558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E39387F-BCD8-4CCE-AD95-9CA8DA7DD3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9892735-9777-4A1E-9ECE-0AC09E4F2A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6C66210-81A8-4FA9-A39C-285218C4F9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7295F-7E20-4672-AE34-97ECF590DF7F}" type="datetimeFigureOut">
              <a:rPr kumimoji="1" lang="ja-JP" altLang="en-US" smtClean="0"/>
              <a:t>2022/7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487521B-BE78-4F27-8A5A-6B5C76901B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B3E0199-C40A-47F8-A4EB-4D2043076C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187A9-53BA-4621-AE58-ABD66CC17D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41406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6B36881-6A51-4757-AC0C-40E0ECA1A3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61023D4-F592-4B6B-B42F-726E1A5DA80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5D425AD-74A9-49C9-9B73-FBD05FD58AB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FA6C2F6-8B78-4793-903A-C2349B0C33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7295F-7E20-4672-AE34-97ECF590DF7F}" type="datetimeFigureOut">
              <a:rPr kumimoji="1" lang="ja-JP" altLang="en-US" smtClean="0"/>
              <a:t>2022/7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CBD6337-2E74-421E-AA9B-82B36FBB96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9ECE518-5669-4180-85A3-BD31AA1313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187A9-53BA-4621-AE58-ABD66CC17D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06541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D125469-93CB-4489-9819-5212A1A401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3D5E7CD-FAED-4D7F-A37C-C24FFA8CBD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59AD76F-6CC9-4105-8697-D9A0E041339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4177FD49-37B3-4A18-BE55-EAD52E59264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A35B55DD-7BEF-4B54-AE56-CD91DC81058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9292725C-5BD2-48B3-ABC0-0748DB6943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7295F-7E20-4672-AE34-97ECF590DF7F}" type="datetimeFigureOut">
              <a:rPr kumimoji="1" lang="ja-JP" altLang="en-US" smtClean="0"/>
              <a:t>2022/7/2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734B44FA-27D8-411C-A52F-8A1E8377FC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BF3372C6-E2FB-448F-B359-39BD0DC77F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187A9-53BA-4621-AE58-ABD66CC17D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44356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813F1B0-88F5-4C4B-88AF-D790B28738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A2E41641-C873-4D8E-B901-D97A527881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7295F-7E20-4672-AE34-97ECF590DF7F}" type="datetimeFigureOut">
              <a:rPr kumimoji="1" lang="ja-JP" altLang="en-US" smtClean="0"/>
              <a:t>2022/7/2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ADB4AB59-F5D3-4F25-B756-790D7864E2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D823BB07-213A-492C-AEE2-541B1ED18E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187A9-53BA-4621-AE58-ABD66CC17D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09856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8AA674B2-7DA2-4D7A-88D6-4B07D616DA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7295F-7E20-4672-AE34-97ECF590DF7F}" type="datetimeFigureOut">
              <a:rPr kumimoji="1" lang="ja-JP" altLang="en-US" smtClean="0"/>
              <a:t>2022/7/2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06E85BB9-9FEF-4DB3-A2A4-6CD99AF55C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64420712-EB22-4B61-B679-40C4B398AB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187A9-53BA-4621-AE58-ABD66CC17D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12619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5969BC2-2205-4088-A3AF-2F4ACB8993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317D8DD-9597-4200-93BB-03DCCE4120E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D275A57-4BC2-4520-8DDA-39EFF357138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8B670AF-6478-405E-B71F-2799290F72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7295F-7E20-4672-AE34-97ECF590DF7F}" type="datetimeFigureOut">
              <a:rPr kumimoji="1" lang="ja-JP" altLang="en-US" smtClean="0"/>
              <a:t>2022/7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79C5A7A-1714-4867-8AAA-48BD0230D5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3972CF8-CDB7-4E74-BB3F-4A5DD2B726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187A9-53BA-4621-AE58-ABD66CC17D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63105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3FF181E-27C2-4174-A8AB-FA201F61FE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B9C41FCE-21F8-48C0-A6B2-F794AC5FF50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020FBF9-1197-4778-A14F-74F5ABEEF01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30A27E7-0BE1-48CC-9613-33845EFA81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7295F-7E20-4672-AE34-97ECF590DF7F}" type="datetimeFigureOut">
              <a:rPr kumimoji="1" lang="ja-JP" altLang="en-US" smtClean="0"/>
              <a:t>2022/7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EFA402E-C05A-4DAC-9BFF-BEF8E9A110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6AE6277-140A-410D-96E7-C64096754D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1187A9-53BA-4621-AE58-ABD66CC17D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19523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D54BF7C9-9F89-4A54-92E0-AD97DC3B7F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2CD766A-46D2-4D07-A1B9-0E2A79C6E07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07F3761-0775-4ED7-878D-7CED341E174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E7295F-7E20-4672-AE34-97ECF590DF7F}" type="datetimeFigureOut">
              <a:rPr kumimoji="1" lang="ja-JP" altLang="en-US" smtClean="0"/>
              <a:t>2022/7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93FD154-629A-4F3E-9AC9-61D7CC7FD1C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640CBA1-8856-42EA-947C-204CC200193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1187A9-53BA-4621-AE58-ABD66CC17D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37445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四角形: 角を丸くする 92">
            <a:extLst>
              <a:ext uri="{FF2B5EF4-FFF2-40B4-BE49-F238E27FC236}">
                <a16:creationId xmlns:a16="http://schemas.microsoft.com/office/drawing/2014/main" id="{1485B3C6-15F4-4C23-9722-757BD307AD28}"/>
              </a:ext>
            </a:extLst>
          </p:cNvPr>
          <p:cNvSpPr/>
          <p:nvPr/>
        </p:nvSpPr>
        <p:spPr>
          <a:xfrm>
            <a:off x="1064474" y="3573029"/>
            <a:ext cx="1348046" cy="623837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2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RBT</a:t>
            </a:r>
            <a:endParaRPr kumimoji="1" lang="ja-JP" altLang="en-US" sz="24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6" name="直線コネクタ 95">
            <a:extLst>
              <a:ext uri="{FF2B5EF4-FFF2-40B4-BE49-F238E27FC236}">
                <a16:creationId xmlns:a16="http://schemas.microsoft.com/office/drawing/2014/main" id="{82E938CB-CFA5-43D7-957A-0E6D40AA8580}"/>
              </a:ext>
            </a:extLst>
          </p:cNvPr>
          <p:cNvCxnSpPr>
            <a:cxnSpLocks/>
          </p:cNvCxnSpPr>
          <p:nvPr/>
        </p:nvCxnSpPr>
        <p:spPr>
          <a:xfrm>
            <a:off x="5540032" y="3739238"/>
            <a:ext cx="0" cy="318052"/>
          </a:xfrm>
          <a:prstGeom prst="line">
            <a:avLst/>
          </a:prstGeom>
          <a:ln w="762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直線コネクタ 101">
            <a:extLst>
              <a:ext uri="{FF2B5EF4-FFF2-40B4-BE49-F238E27FC236}">
                <a16:creationId xmlns:a16="http://schemas.microsoft.com/office/drawing/2014/main" id="{97E54A80-6B37-49C8-8502-C693A1D0F805}"/>
              </a:ext>
            </a:extLst>
          </p:cNvPr>
          <p:cNvCxnSpPr/>
          <p:nvPr/>
        </p:nvCxnSpPr>
        <p:spPr>
          <a:xfrm>
            <a:off x="6559509" y="3739238"/>
            <a:ext cx="0" cy="318052"/>
          </a:xfrm>
          <a:prstGeom prst="line">
            <a:avLst/>
          </a:prstGeom>
          <a:ln w="762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直線コネクタ 105">
            <a:extLst>
              <a:ext uri="{FF2B5EF4-FFF2-40B4-BE49-F238E27FC236}">
                <a16:creationId xmlns:a16="http://schemas.microsoft.com/office/drawing/2014/main" id="{ADBE9CE1-2C9C-4DFC-91D5-1A15E99AC91D}"/>
              </a:ext>
            </a:extLst>
          </p:cNvPr>
          <p:cNvCxnSpPr>
            <a:cxnSpLocks/>
          </p:cNvCxnSpPr>
          <p:nvPr/>
        </p:nvCxnSpPr>
        <p:spPr>
          <a:xfrm>
            <a:off x="7578986" y="3739238"/>
            <a:ext cx="0" cy="318052"/>
          </a:xfrm>
          <a:prstGeom prst="line">
            <a:avLst/>
          </a:prstGeom>
          <a:ln w="762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直線コネクタ 107">
            <a:extLst>
              <a:ext uri="{FF2B5EF4-FFF2-40B4-BE49-F238E27FC236}">
                <a16:creationId xmlns:a16="http://schemas.microsoft.com/office/drawing/2014/main" id="{B4CF386B-C910-4FAE-B000-98FE485C5582}"/>
              </a:ext>
            </a:extLst>
          </p:cNvPr>
          <p:cNvCxnSpPr>
            <a:cxnSpLocks/>
          </p:cNvCxnSpPr>
          <p:nvPr/>
        </p:nvCxnSpPr>
        <p:spPr>
          <a:xfrm>
            <a:off x="9037271" y="3739238"/>
            <a:ext cx="0" cy="318052"/>
          </a:xfrm>
          <a:prstGeom prst="line">
            <a:avLst/>
          </a:prstGeom>
          <a:ln w="762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直線コネクタ 109">
            <a:extLst>
              <a:ext uri="{FF2B5EF4-FFF2-40B4-BE49-F238E27FC236}">
                <a16:creationId xmlns:a16="http://schemas.microsoft.com/office/drawing/2014/main" id="{BFD7A0BF-42D8-4765-8651-F8D9ED15490D}"/>
              </a:ext>
            </a:extLst>
          </p:cNvPr>
          <p:cNvCxnSpPr/>
          <p:nvPr/>
        </p:nvCxnSpPr>
        <p:spPr>
          <a:xfrm>
            <a:off x="10059376" y="3739238"/>
            <a:ext cx="0" cy="318052"/>
          </a:xfrm>
          <a:prstGeom prst="line">
            <a:avLst/>
          </a:prstGeom>
          <a:ln w="762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6" name="四角形: 角を丸くする 115">
            <a:extLst>
              <a:ext uri="{FF2B5EF4-FFF2-40B4-BE49-F238E27FC236}">
                <a16:creationId xmlns:a16="http://schemas.microsoft.com/office/drawing/2014/main" id="{C5B7C20C-8123-4006-93DF-808B98EDDC11}"/>
              </a:ext>
            </a:extLst>
          </p:cNvPr>
          <p:cNvSpPr/>
          <p:nvPr/>
        </p:nvSpPr>
        <p:spPr>
          <a:xfrm>
            <a:off x="5129746" y="1763698"/>
            <a:ext cx="5335916" cy="623837"/>
          </a:xfrm>
          <a:prstGeom prst="roundRect">
            <a:avLst/>
          </a:prstGeom>
          <a:solidFill>
            <a:srgbClr val="00B0F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CG×6</a:t>
            </a: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  <a:r>
              <a:rPr kumimoji="1" lang="en-US" altLang="ja-JP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 times</a:t>
            </a:r>
          </a:p>
          <a:p>
            <a:pPr algn="ctr"/>
            <a:r>
              <a:rPr lang="en-US" altLang="ja-JP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ithout maintenance</a:t>
            </a:r>
            <a:endParaRPr kumimoji="1" lang="ja-JP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四角形: 角を丸くする 119">
            <a:extLst>
              <a:ext uri="{FF2B5EF4-FFF2-40B4-BE49-F238E27FC236}">
                <a16:creationId xmlns:a16="http://schemas.microsoft.com/office/drawing/2014/main" id="{41CF9370-4049-43F0-84C1-B1A3327B09A1}"/>
              </a:ext>
            </a:extLst>
          </p:cNvPr>
          <p:cNvSpPr/>
          <p:nvPr/>
        </p:nvSpPr>
        <p:spPr>
          <a:xfrm>
            <a:off x="5129746" y="2572630"/>
            <a:ext cx="810525" cy="623837"/>
          </a:xfrm>
          <a:prstGeom prst="roundRect">
            <a:avLst/>
          </a:prstGeom>
          <a:solidFill>
            <a:srgbClr val="FF9999"/>
          </a:solidFill>
          <a:ln>
            <a:solidFill>
              <a:srgbClr val="FF9999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BCG</a:t>
            </a:r>
            <a:endParaRPr kumimoji="1" lang="en-US" altLang="ja-JP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矢印: 下 40">
            <a:extLst>
              <a:ext uri="{FF2B5EF4-FFF2-40B4-BE49-F238E27FC236}">
                <a16:creationId xmlns:a16="http://schemas.microsoft.com/office/drawing/2014/main" id="{F420F502-F12F-4322-A5DD-E4143A632B7F}"/>
              </a:ext>
            </a:extLst>
          </p:cNvPr>
          <p:cNvSpPr/>
          <p:nvPr/>
        </p:nvSpPr>
        <p:spPr>
          <a:xfrm>
            <a:off x="5459200" y="3364960"/>
            <a:ext cx="151618" cy="225449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0" name="矢印: 下 129">
            <a:extLst>
              <a:ext uri="{FF2B5EF4-FFF2-40B4-BE49-F238E27FC236}">
                <a16:creationId xmlns:a16="http://schemas.microsoft.com/office/drawing/2014/main" id="{A8044718-EC84-4C26-A934-B70A628A1E1E}"/>
              </a:ext>
            </a:extLst>
          </p:cNvPr>
          <p:cNvSpPr/>
          <p:nvPr/>
        </p:nvSpPr>
        <p:spPr>
          <a:xfrm>
            <a:off x="6488025" y="3364960"/>
            <a:ext cx="151618" cy="225449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1" name="矢印: 下 130">
            <a:extLst>
              <a:ext uri="{FF2B5EF4-FFF2-40B4-BE49-F238E27FC236}">
                <a16:creationId xmlns:a16="http://schemas.microsoft.com/office/drawing/2014/main" id="{F8F68FCF-E63B-4E09-9452-4B7D6E9B4B64}"/>
              </a:ext>
            </a:extLst>
          </p:cNvPr>
          <p:cNvSpPr/>
          <p:nvPr/>
        </p:nvSpPr>
        <p:spPr>
          <a:xfrm>
            <a:off x="7511589" y="3364960"/>
            <a:ext cx="151618" cy="225449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2" name="矢印: 下 131">
            <a:extLst>
              <a:ext uri="{FF2B5EF4-FFF2-40B4-BE49-F238E27FC236}">
                <a16:creationId xmlns:a16="http://schemas.microsoft.com/office/drawing/2014/main" id="{107A169A-73C2-47F7-A819-A2611331B88C}"/>
              </a:ext>
            </a:extLst>
          </p:cNvPr>
          <p:cNvSpPr/>
          <p:nvPr/>
        </p:nvSpPr>
        <p:spPr>
          <a:xfrm>
            <a:off x="8971335" y="3364960"/>
            <a:ext cx="151618" cy="225449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3" name="矢印: 下 132">
            <a:extLst>
              <a:ext uri="{FF2B5EF4-FFF2-40B4-BE49-F238E27FC236}">
                <a16:creationId xmlns:a16="http://schemas.microsoft.com/office/drawing/2014/main" id="{AC6E40D6-EAB1-4407-8A81-689AEB3C1A6E}"/>
              </a:ext>
            </a:extLst>
          </p:cNvPr>
          <p:cNvSpPr/>
          <p:nvPr/>
        </p:nvSpPr>
        <p:spPr>
          <a:xfrm>
            <a:off x="9989647" y="3364960"/>
            <a:ext cx="151618" cy="225449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3" name="矢印: 下 42">
            <a:extLst>
              <a:ext uri="{FF2B5EF4-FFF2-40B4-BE49-F238E27FC236}">
                <a16:creationId xmlns:a16="http://schemas.microsoft.com/office/drawing/2014/main" id="{D68D1DBC-EE99-409B-9BE4-A5E39C49B85D}"/>
              </a:ext>
            </a:extLst>
          </p:cNvPr>
          <p:cNvSpPr/>
          <p:nvPr/>
        </p:nvSpPr>
        <p:spPr>
          <a:xfrm rot="16200000">
            <a:off x="9576575" y="2677073"/>
            <a:ext cx="160284" cy="2462919"/>
          </a:xfrm>
          <a:prstGeom prst="downArrow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23449CE1-9FE7-60FB-9C3A-B4D38BF40258}"/>
              </a:ext>
            </a:extLst>
          </p:cNvPr>
          <p:cNvSpPr txBox="1"/>
          <p:nvPr/>
        </p:nvSpPr>
        <p:spPr>
          <a:xfrm>
            <a:off x="696141" y="1222966"/>
            <a:ext cx="10423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. S1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右中かっこ 1">
            <a:extLst>
              <a:ext uri="{FF2B5EF4-FFF2-40B4-BE49-F238E27FC236}">
                <a16:creationId xmlns:a16="http://schemas.microsoft.com/office/drawing/2014/main" id="{9BC53550-BA3A-B0EC-91A0-CDCF4C211D76}"/>
              </a:ext>
            </a:extLst>
          </p:cNvPr>
          <p:cNvSpPr/>
          <p:nvPr/>
        </p:nvSpPr>
        <p:spPr>
          <a:xfrm rot="5400000">
            <a:off x="3823941" y="2836467"/>
            <a:ext cx="225451" cy="3045067"/>
          </a:xfrm>
          <a:prstGeom prst="rightBrac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1AD0904D-09AC-F62D-6B66-FFF7B9597B33}"/>
              </a:ext>
            </a:extLst>
          </p:cNvPr>
          <p:cNvSpPr txBox="1"/>
          <p:nvPr/>
        </p:nvSpPr>
        <p:spPr>
          <a:xfrm>
            <a:off x="3295767" y="4518995"/>
            <a:ext cx="13626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4–6 weeks</a:t>
            </a:r>
          </a:p>
        </p:txBody>
      </p:sp>
      <p:sp>
        <p:nvSpPr>
          <p:cNvPr id="42" name="右中かっこ 41">
            <a:extLst>
              <a:ext uri="{FF2B5EF4-FFF2-40B4-BE49-F238E27FC236}">
                <a16:creationId xmlns:a16="http://schemas.microsoft.com/office/drawing/2014/main" id="{562FE03A-2C26-6151-803D-AFB290F1BD86}"/>
              </a:ext>
            </a:extLst>
          </p:cNvPr>
          <p:cNvSpPr/>
          <p:nvPr/>
        </p:nvSpPr>
        <p:spPr>
          <a:xfrm rot="5400000">
            <a:off x="5940379" y="3916714"/>
            <a:ext cx="225450" cy="884576"/>
          </a:xfrm>
          <a:prstGeom prst="rightBrac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63B77BA2-6432-14B3-8E6D-7C9665CBE437}"/>
              </a:ext>
            </a:extLst>
          </p:cNvPr>
          <p:cNvSpPr txBox="1"/>
          <p:nvPr/>
        </p:nvSpPr>
        <p:spPr>
          <a:xfrm>
            <a:off x="5546182" y="4518995"/>
            <a:ext cx="9896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1 week</a:t>
            </a:r>
          </a:p>
        </p:txBody>
      </p:sp>
      <p:sp>
        <p:nvSpPr>
          <p:cNvPr id="45" name="右中かっこ 44">
            <a:extLst>
              <a:ext uri="{FF2B5EF4-FFF2-40B4-BE49-F238E27FC236}">
                <a16:creationId xmlns:a16="http://schemas.microsoft.com/office/drawing/2014/main" id="{A18808AB-6DAC-B808-EEBC-290EFE02DAAF}"/>
              </a:ext>
            </a:extLst>
          </p:cNvPr>
          <p:cNvSpPr/>
          <p:nvPr/>
        </p:nvSpPr>
        <p:spPr>
          <a:xfrm rot="5400000">
            <a:off x="6953706" y="3916714"/>
            <a:ext cx="225450" cy="884576"/>
          </a:xfrm>
          <a:prstGeom prst="rightBrac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86B4019E-D609-ED33-25FF-638A144584C3}"/>
              </a:ext>
            </a:extLst>
          </p:cNvPr>
          <p:cNvSpPr txBox="1"/>
          <p:nvPr/>
        </p:nvSpPr>
        <p:spPr>
          <a:xfrm>
            <a:off x="6559509" y="4518995"/>
            <a:ext cx="9896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1 week</a:t>
            </a:r>
          </a:p>
        </p:txBody>
      </p:sp>
      <p:sp>
        <p:nvSpPr>
          <p:cNvPr id="47" name="四角形: 角を丸くする 46">
            <a:extLst>
              <a:ext uri="{FF2B5EF4-FFF2-40B4-BE49-F238E27FC236}">
                <a16:creationId xmlns:a16="http://schemas.microsoft.com/office/drawing/2014/main" id="{86A0998F-4408-6F1D-16DD-BA3810E3E63F}"/>
              </a:ext>
            </a:extLst>
          </p:cNvPr>
          <p:cNvSpPr/>
          <p:nvPr/>
        </p:nvSpPr>
        <p:spPr>
          <a:xfrm>
            <a:off x="6154246" y="2572630"/>
            <a:ext cx="810525" cy="623837"/>
          </a:xfrm>
          <a:prstGeom prst="roundRect">
            <a:avLst/>
          </a:prstGeom>
          <a:solidFill>
            <a:srgbClr val="FF9999"/>
          </a:solidFill>
          <a:ln>
            <a:solidFill>
              <a:srgbClr val="FF9999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BCG</a:t>
            </a:r>
            <a:endParaRPr kumimoji="1" lang="en-US" altLang="ja-JP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四角形: 角を丸くする 47">
            <a:extLst>
              <a:ext uri="{FF2B5EF4-FFF2-40B4-BE49-F238E27FC236}">
                <a16:creationId xmlns:a16="http://schemas.microsoft.com/office/drawing/2014/main" id="{A5B00119-B2A2-88B3-02CF-951AA3C243B5}"/>
              </a:ext>
            </a:extLst>
          </p:cNvPr>
          <p:cNvSpPr/>
          <p:nvPr/>
        </p:nvSpPr>
        <p:spPr>
          <a:xfrm>
            <a:off x="7182135" y="2572630"/>
            <a:ext cx="810525" cy="623837"/>
          </a:xfrm>
          <a:prstGeom prst="roundRect">
            <a:avLst/>
          </a:prstGeom>
          <a:solidFill>
            <a:srgbClr val="FF9999"/>
          </a:solidFill>
          <a:ln>
            <a:solidFill>
              <a:srgbClr val="FF9999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BCG</a:t>
            </a:r>
            <a:endParaRPr kumimoji="1" lang="en-US" altLang="ja-JP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" name="直線コネクタ 48">
            <a:extLst>
              <a:ext uri="{FF2B5EF4-FFF2-40B4-BE49-F238E27FC236}">
                <a16:creationId xmlns:a16="http://schemas.microsoft.com/office/drawing/2014/main" id="{EA3555B9-F791-018A-4131-A35C8A379885}"/>
              </a:ext>
            </a:extLst>
          </p:cNvPr>
          <p:cNvCxnSpPr>
            <a:cxnSpLocks/>
          </p:cNvCxnSpPr>
          <p:nvPr/>
        </p:nvCxnSpPr>
        <p:spPr>
          <a:xfrm flipH="1" flipV="1">
            <a:off x="2401062" y="3890031"/>
            <a:ext cx="5813044" cy="18873"/>
          </a:xfrm>
          <a:prstGeom prst="line">
            <a:avLst/>
          </a:prstGeom>
          <a:ln w="762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フリーフォーム: 図形 7">
            <a:extLst>
              <a:ext uri="{FF2B5EF4-FFF2-40B4-BE49-F238E27FC236}">
                <a16:creationId xmlns:a16="http://schemas.microsoft.com/office/drawing/2014/main" id="{BEFA392C-7B0E-4E07-639B-D64763AF7461}"/>
              </a:ext>
            </a:extLst>
          </p:cNvPr>
          <p:cNvSpPr/>
          <p:nvPr/>
        </p:nvSpPr>
        <p:spPr>
          <a:xfrm>
            <a:off x="8138297" y="3685134"/>
            <a:ext cx="151618" cy="443713"/>
          </a:xfrm>
          <a:custGeom>
            <a:avLst/>
            <a:gdLst>
              <a:gd name="connsiteX0" fmla="*/ 0 w 99958"/>
              <a:gd name="connsiteY0" fmla="*/ 0 h 483476"/>
              <a:gd name="connsiteX1" fmla="*/ 99848 w 99958"/>
              <a:gd name="connsiteY1" fmla="*/ 178676 h 483476"/>
              <a:gd name="connsiteX2" fmla="*/ 21020 w 99958"/>
              <a:gd name="connsiteY2" fmla="*/ 325821 h 483476"/>
              <a:gd name="connsiteX3" fmla="*/ 89338 w 99958"/>
              <a:gd name="connsiteY3" fmla="*/ 483476 h 48347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9958" h="483476">
                <a:moveTo>
                  <a:pt x="0" y="0"/>
                </a:moveTo>
                <a:cubicBezTo>
                  <a:pt x="48172" y="62186"/>
                  <a:pt x="96345" y="124373"/>
                  <a:pt x="99848" y="178676"/>
                </a:cubicBezTo>
                <a:cubicBezTo>
                  <a:pt x="103351" y="232979"/>
                  <a:pt x="22772" y="275021"/>
                  <a:pt x="21020" y="325821"/>
                </a:cubicBezTo>
                <a:cubicBezTo>
                  <a:pt x="19268" y="376621"/>
                  <a:pt x="54303" y="430048"/>
                  <a:pt x="89338" y="483476"/>
                </a:cubicBezTo>
              </a:path>
            </a:pathLst>
          </a:custGeom>
          <a:noFill/>
          <a:ln w="4445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4" name="フリーフォーム: 図形 53">
            <a:extLst>
              <a:ext uri="{FF2B5EF4-FFF2-40B4-BE49-F238E27FC236}">
                <a16:creationId xmlns:a16="http://schemas.microsoft.com/office/drawing/2014/main" id="{0DB5C286-9D4F-E1BE-560A-7303FF4C65A1}"/>
              </a:ext>
            </a:extLst>
          </p:cNvPr>
          <p:cNvSpPr/>
          <p:nvPr/>
        </p:nvSpPr>
        <p:spPr>
          <a:xfrm>
            <a:off x="8273637" y="3685133"/>
            <a:ext cx="151618" cy="443713"/>
          </a:xfrm>
          <a:custGeom>
            <a:avLst/>
            <a:gdLst>
              <a:gd name="connsiteX0" fmla="*/ 0 w 99958"/>
              <a:gd name="connsiteY0" fmla="*/ 0 h 483476"/>
              <a:gd name="connsiteX1" fmla="*/ 99848 w 99958"/>
              <a:gd name="connsiteY1" fmla="*/ 178676 h 483476"/>
              <a:gd name="connsiteX2" fmla="*/ 21020 w 99958"/>
              <a:gd name="connsiteY2" fmla="*/ 325821 h 483476"/>
              <a:gd name="connsiteX3" fmla="*/ 89338 w 99958"/>
              <a:gd name="connsiteY3" fmla="*/ 483476 h 48347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9958" h="483476">
                <a:moveTo>
                  <a:pt x="0" y="0"/>
                </a:moveTo>
                <a:cubicBezTo>
                  <a:pt x="48172" y="62186"/>
                  <a:pt x="96345" y="124373"/>
                  <a:pt x="99848" y="178676"/>
                </a:cubicBezTo>
                <a:cubicBezTo>
                  <a:pt x="103351" y="232979"/>
                  <a:pt x="22772" y="275021"/>
                  <a:pt x="21020" y="325821"/>
                </a:cubicBezTo>
                <a:cubicBezTo>
                  <a:pt x="19268" y="376621"/>
                  <a:pt x="54303" y="430048"/>
                  <a:pt x="89338" y="483476"/>
                </a:cubicBezTo>
              </a:path>
            </a:pathLst>
          </a:custGeom>
          <a:noFill/>
          <a:ln w="4445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5" name="四角形: 角を丸くする 54">
            <a:extLst>
              <a:ext uri="{FF2B5EF4-FFF2-40B4-BE49-F238E27FC236}">
                <a16:creationId xmlns:a16="http://schemas.microsoft.com/office/drawing/2014/main" id="{E53D811F-C25C-CF5B-32B1-DA90361ED63E}"/>
              </a:ext>
            </a:extLst>
          </p:cNvPr>
          <p:cNvSpPr/>
          <p:nvPr/>
        </p:nvSpPr>
        <p:spPr>
          <a:xfrm>
            <a:off x="8636626" y="2572630"/>
            <a:ext cx="810525" cy="623837"/>
          </a:xfrm>
          <a:prstGeom prst="roundRect">
            <a:avLst/>
          </a:prstGeom>
          <a:solidFill>
            <a:srgbClr val="FF9999"/>
          </a:solidFill>
          <a:ln>
            <a:solidFill>
              <a:srgbClr val="FF9999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BCG</a:t>
            </a:r>
            <a:endParaRPr kumimoji="1" lang="en-US" altLang="ja-JP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四角形: 角を丸くする 55">
            <a:extLst>
              <a:ext uri="{FF2B5EF4-FFF2-40B4-BE49-F238E27FC236}">
                <a16:creationId xmlns:a16="http://schemas.microsoft.com/office/drawing/2014/main" id="{59D497CA-012E-1F64-9CE9-CF33B0EB5772}"/>
              </a:ext>
            </a:extLst>
          </p:cNvPr>
          <p:cNvSpPr/>
          <p:nvPr/>
        </p:nvSpPr>
        <p:spPr>
          <a:xfrm>
            <a:off x="9655137" y="2572630"/>
            <a:ext cx="810525" cy="623837"/>
          </a:xfrm>
          <a:prstGeom prst="roundRect">
            <a:avLst/>
          </a:prstGeom>
          <a:solidFill>
            <a:srgbClr val="FF9999"/>
          </a:solidFill>
          <a:ln>
            <a:solidFill>
              <a:srgbClr val="FF9999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BCG</a:t>
            </a:r>
            <a:endParaRPr kumimoji="1" lang="en-US" altLang="ja-JP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右中かっこ 56">
            <a:extLst>
              <a:ext uri="{FF2B5EF4-FFF2-40B4-BE49-F238E27FC236}">
                <a16:creationId xmlns:a16="http://schemas.microsoft.com/office/drawing/2014/main" id="{2B88ECEE-E2BC-50A9-50EE-CEC876817308}"/>
              </a:ext>
            </a:extLst>
          </p:cNvPr>
          <p:cNvSpPr/>
          <p:nvPr/>
        </p:nvSpPr>
        <p:spPr>
          <a:xfrm rot="5400000">
            <a:off x="9454986" y="3916714"/>
            <a:ext cx="225450" cy="884576"/>
          </a:xfrm>
          <a:prstGeom prst="rightBrac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4EA63216-E4B3-DD77-BBBC-90BDF8124EE2}"/>
              </a:ext>
            </a:extLst>
          </p:cNvPr>
          <p:cNvSpPr txBox="1"/>
          <p:nvPr/>
        </p:nvSpPr>
        <p:spPr>
          <a:xfrm>
            <a:off x="9060789" y="4518995"/>
            <a:ext cx="9896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1 week</a:t>
            </a: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9EC71D9C-0344-88D9-9056-15A54BF9F9AC}"/>
              </a:ext>
            </a:extLst>
          </p:cNvPr>
          <p:cNvSpPr txBox="1"/>
          <p:nvPr/>
        </p:nvSpPr>
        <p:spPr>
          <a:xfrm>
            <a:off x="10888177" y="3716046"/>
            <a:ext cx="134804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800" b="1" kern="0" dirty="0"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Follow-up</a:t>
            </a:r>
            <a:endParaRPr lang="ja-JP" altLang="en-US" dirty="0"/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4750F160-CB9A-9F90-4CC3-0D1578A01958}"/>
              </a:ext>
            </a:extLst>
          </p:cNvPr>
          <p:cNvSpPr txBox="1"/>
          <p:nvPr/>
        </p:nvSpPr>
        <p:spPr>
          <a:xfrm>
            <a:off x="1064473" y="5297939"/>
            <a:ext cx="10954105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eaLnBrk="0" hangingPunct="0"/>
            <a:r>
              <a:rPr lang="en-US" altLang="ja-JP" sz="12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ig. S1 Schema of the schedule of bacillus Calmette-</a:t>
            </a:r>
            <a:r>
              <a:rPr lang="en-US" altLang="ja-JP" sz="1200" b="1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Guérin</a:t>
            </a:r>
            <a:r>
              <a:rPr lang="en-US" altLang="ja-JP" sz="12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(BCG) therapy</a:t>
            </a:r>
          </a:p>
          <a:p>
            <a:pPr algn="just" eaLnBrk="0" hangingPunct="0"/>
            <a:endParaRPr lang="ja-JP" altLang="ja-JP" sz="12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 eaLnBrk="0" hangingPunct="0"/>
            <a:r>
              <a:rPr lang="en-US" altLang="ja-JP" sz="12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atients received intravesical instillation of BCG 4 to 6 weeks after transurethral resection of bladder tumor (TURBT). The procedure was repeated once weekly for 6 or 8 weeks. </a:t>
            </a:r>
            <a:endParaRPr lang="ja-JP" altLang="ja-JP" sz="12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707137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91AA00A-C383-40A3-997F-16009C8A906B}"/>
              </a:ext>
            </a:extLst>
          </p:cNvPr>
          <p:cNvSpPr txBox="1"/>
          <p:nvPr/>
        </p:nvSpPr>
        <p:spPr>
          <a:xfrm>
            <a:off x="1841704" y="1764317"/>
            <a:ext cx="4864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C5B08056-6060-4532-966E-41F6A92E0D19}"/>
              </a:ext>
            </a:extLst>
          </p:cNvPr>
          <p:cNvSpPr txBox="1"/>
          <p:nvPr/>
        </p:nvSpPr>
        <p:spPr>
          <a:xfrm>
            <a:off x="1345130" y="1194119"/>
            <a:ext cx="10423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. S2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45A41D7E-F97A-47D6-80EC-697D2FEF59C1}"/>
              </a:ext>
            </a:extLst>
          </p:cNvPr>
          <p:cNvSpPr txBox="1"/>
          <p:nvPr/>
        </p:nvSpPr>
        <p:spPr>
          <a:xfrm>
            <a:off x="6097310" y="1764317"/>
            <a:ext cx="4864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オブジェクト 6">
            <a:extLst>
              <a:ext uri="{FF2B5EF4-FFF2-40B4-BE49-F238E27FC236}">
                <a16:creationId xmlns:a16="http://schemas.microsoft.com/office/drawing/2014/main" id="{E3609FA7-FC02-4D68-8DC4-46D72EF7071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0830333"/>
              </p:ext>
            </p:extLst>
          </p:nvPr>
        </p:nvGraphicFramePr>
        <p:xfrm>
          <a:off x="6254130" y="1989137"/>
          <a:ext cx="3816350" cy="2879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Project" r:id="rId2" imgW="3816000" imgH="2880000" progId="Prism5.Document">
                  <p:embed/>
                </p:oleObj>
              </mc:Choice>
              <mc:Fallback>
                <p:oleObj name="Prism Project" r:id="rId2" imgW="3816000" imgH="2880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254130" y="1989137"/>
                        <a:ext cx="3816350" cy="2879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オブジェクト 8">
            <a:extLst>
              <a:ext uri="{FF2B5EF4-FFF2-40B4-BE49-F238E27FC236}">
                <a16:creationId xmlns:a16="http://schemas.microsoft.com/office/drawing/2014/main" id="{002C0ACC-1317-4192-A65C-0DECDBE561F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57162356"/>
              </p:ext>
            </p:extLst>
          </p:nvPr>
        </p:nvGraphicFramePr>
        <p:xfrm>
          <a:off x="1992293" y="1989135"/>
          <a:ext cx="3779837" cy="2879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Project" r:id="rId4" imgW="3780000" imgH="2880000" progId="Prism5.Document">
                  <p:embed/>
                </p:oleObj>
              </mc:Choice>
              <mc:Fallback>
                <p:oleObj name="Prism Project" r:id="rId4" imgW="3780000" imgH="2880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992293" y="1989135"/>
                        <a:ext cx="3779837" cy="2879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56CFF70F-F95A-49AE-9B9F-24598158F8D0}"/>
              </a:ext>
            </a:extLst>
          </p:cNvPr>
          <p:cNvSpPr txBox="1"/>
          <p:nvPr/>
        </p:nvSpPr>
        <p:spPr>
          <a:xfrm>
            <a:off x="1390513" y="5156049"/>
            <a:ext cx="8763234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eaLnBrk="0" hangingPunct="0"/>
            <a:r>
              <a:rPr lang="en-US" altLang="ja-JP" sz="12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ig. S2 Differences in oncological outcomes between patients with asymptomatic and symptomatic upper urinary tract recurrences</a:t>
            </a:r>
          </a:p>
          <a:p>
            <a:pPr algn="just" eaLnBrk="0" hangingPunct="0"/>
            <a:endParaRPr lang="ja-JP" altLang="ja-JP" sz="12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 eaLnBrk="0" hangingPunct="0"/>
            <a:r>
              <a:rPr lang="en-US" altLang="ja-JP" sz="12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Cancer-specific survival (</a:t>
            </a:r>
            <a:r>
              <a:rPr lang="en-US" altLang="ja-JP" sz="1200" b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</a:t>
            </a:r>
            <a:r>
              <a:rPr lang="en-US" altLang="ja-JP" sz="12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) and overall survival (</a:t>
            </a:r>
            <a:r>
              <a:rPr lang="en-US" altLang="ja-JP" sz="1200" b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B</a:t>
            </a:r>
            <a:r>
              <a:rPr lang="en-US" altLang="ja-JP" sz="12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) were evaluated using </a:t>
            </a:r>
            <a:r>
              <a:rPr lang="en-US" altLang="ja-JP" sz="12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he Kaplan–Meier method and compared using the log-rank test.</a:t>
            </a:r>
            <a:r>
              <a:rPr lang="en-US" altLang="ja-JP" sz="12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UUT, </a:t>
            </a:r>
            <a:r>
              <a:rPr lang="en-US" altLang="ja-JP" sz="12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upper urinary tract.</a:t>
            </a:r>
            <a:endParaRPr lang="ja-JP" altLang="ja-JP" sz="12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606283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</TotalTime>
  <Words>124</Words>
  <Application>Microsoft Office PowerPoint</Application>
  <PresentationFormat>ワイド画面</PresentationFormat>
  <Paragraphs>24</Paragraphs>
  <Slides>2</Slides>
  <Notes>1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ゴシック</vt:lpstr>
      <vt:lpstr>游ゴシック Light</vt:lpstr>
      <vt:lpstr>Arial</vt:lpstr>
      <vt:lpstr>Office テーマ</vt:lpstr>
      <vt:lpstr>Prism Project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尚紀 藤田</dc:creator>
  <cp:lastModifiedBy>藤田　尚紀</cp:lastModifiedBy>
  <cp:revision>99</cp:revision>
  <dcterms:created xsi:type="dcterms:W3CDTF">2019-11-11T11:22:04Z</dcterms:created>
  <dcterms:modified xsi:type="dcterms:W3CDTF">2022-07-22T10:15:43Z</dcterms:modified>
</cp:coreProperties>
</file>